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43;p16"/>
          <p:cNvSpPr txBox="1"/>
          <p:nvPr/>
        </p:nvSpPr>
        <p:spPr bwMode="auto">
          <a:xfrm>
            <a:off x="2060427" y="4758372"/>
            <a:ext cx="8469720" cy="10058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 Figure S</a:t>
            </a:r>
            <a:r>
              <a:rPr lang="fr-FR" sz="1500" b="1"/>
              <a:t>8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Glycemia in WT (n = 20) and cKO (n = 18) mice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.  Mice (5-months old) were fasted for 6 h, followed by blood sampling as described in Materials and Methods.  Blood glucose was measured using a calibrated glucometer. Results are shown as mean ± SEM, </a:t>
            </a:r>
            <a:r>
              <a:rPr lang="en-US" sz="1500" b="0" i="0" u="none" strike="noStrike" cap="none" spc="0">
                <a:solidFill>
                  <a:srgbClr val="000000"/>
                </a:solidFill>
                <a:latin typeface="Arial"/>
                <a:ea typeface="Arial"/>
                <a:cs typeface="Arial"/>
              </a:rPr>
              <a:t>No statistical differences were observed between WT and cKO mice.</a:t>
            </a:r>
            <a:endParaRPr sz="15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  <p:grpSp>
        <p:nvGrpSpPr>
          <p:cNvPr id="5" name="Google Shape;144;p16"/>
          <p:cNvGrpSpPr/>
          <p:nvPr/>
        </p:nvGrpSpPr>
        <p:grpSpPr bwMode="auto">
          <a:xfrm>
            <a:off x="3903235" y="1081548"/>
            <a:ext cx="4385532" cy="3011712"/>
            <a:chOff x="3918624" y="786581"/>
            <a:chExt cx="4385532" cy="3011712"/>
          </a:xfrm>
        </p:grpSpPr>
        <p:pic>
          <p:nvPicPr>
            <p:cNvPr id="6" name="Google Shape;145;p16"/>
            <p:cNvPicPr/>
            <p:nvPr/>
          </p:nvPicPr>
          <p:blipFill>
            <a:blip r:embed="rId2">
              <a:alphaModFix/>
            </a:blip>
            <a:srcRect l="9703" t="11764" b="21388"/>
            <a:stretch/>
          </p:blipFill>
          <p:spPr bwMode="auto">
            <a:xfrm>
              <a:off x="4316361" y="786581"/>
              <a:ext cx="3987794" cy="270393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" name="Google Shape;146;p16"/>
            <p:cNvSpPr txBox="1"/>
            <p:nvPr/>
          </p:nvSpPr>
          <p:spPr bwMode="auto">
            <a:xfrm rot="-5400000">
              <a:off x="3229172" y="1950245"/>
              <a:ext cx="1686680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/>
              </a:pPr>
              <a:r>
                <a:rPr lang="fr-FR" sz="140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Glycemia (mg/dL)</a:t>
              </a:r>
              <a:endParaRPr/>
            </a:p>
          </p:txBody>
        </p:sp>
        <p:sp>
          <p:nvSpPr>
            <p:cNvPr id="8" name="Google Shape;147;p16"/>
            <p:cNvSpPr txBox="1"/>
            <p:nvPr/>
          </p:nvSpPr>
          <p:spPr bwMode="auto">
            <a:xfrm>
              <a:off x="5368413" y="3490516"/>
              <a:ext cx="463588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WT</a:t>
              </a:r>
              <a:endParaRPr/>
            </a:p>
          </p:txBody>
        </p:sp>
        <p:sp>
          <p:nvSpPr>
            <p:cNvPr id="9" name="Google Shape;148;p16"/>
            <p:cNvSpPr txBox="1"/>
            <p:nvPr/>
          </p:nvSpPr>
          <p:spPr bwMode="auto">
            <a:xfrm>
              <a:off x="7101357" y="3490516"/>
              <a:ext cx="53412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defRPr/>
              </a:pPr>
              <a:r>
                <a:rPr lang="fr-FR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</a:rPr>
                <a:t>cKO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689319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7</Words>
  <Application>Microsoft Office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6</cp:revision>
  <dcterms:created xsi:type="dcterms:W3CDTF">2022-01-28T21:57:26Z</dcterms:created>
  <dcterms:modified xsi:type="dcterms:W3CDTF">2022-01-28T22:00:55Z</dcterms:modified>
</cp:coreProperties>
</file>